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78" r:id="rId2"/>
  </p:sldIdLst>
  <p:sldSz cx="9906000" cy="6858000" type="A4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20F0"/>
    <a:srgbClr val="FFFF00"/>
    <a:srgbClr val="0000FF"/>
    <a:srgbClr val="DAA600"/>
    <a:srgbClr val="ACA800"/>
    <a:srgbClr val="C06000"/>
    <a:srgbClr val="E6BA00"/>
    <a:srgbClr val="00CC00"/>
    <a:srgbClr val="0066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8D31B1-23BA-48C2-A786-2A935BCDF100}" v="1" dt="2025-10-23T23:48:18.80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512" y="9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restha, Avinash" userId="5add98df-411e-49d5-8233-8d4857106cf3" providerId="ADAL" clId="{B598BFAD-5F30-4432-A8E7-25629D7821CF}"/>
    <pc:docChg chg="custSel modSld">
      <pc:chgData name="Shrestha, Avinash" userId="5add98df-411e-49d5-8233-8d4857106cf3" providerId="ADAL" clId="{B598BFAD-5F30-4432-A8E7-25629D7821CF}" dt="2025-10-23T23:50:09.035" v="9" actId="255"/>
      <pc:docMkLst>
        <pc:docMk/>
      </pc:docMkLst>
      <pc:sldChg chg="addSp delSp modSp mod">
        <pc:chgData name="Shrestha, Avinash" userId="5add98df-411e-49d5-8233-8d4857106cf3" providerId="ADAL" clId="{B598BFAD-5F30-4432-A8E7-25629D7821CF}" dt="2025-10-23T23:50:09.035" v="9" actId="255"/>
        <pc:sldMkLst>
          <pc:docMk/>
          <pc:sldMk cId="2100341470" sldId="378"/>
        </pc:sldMkLst>
        <pc:spChg chg="add mod">
          <ac:chgData name="Shrestha, Avinash" userId="5add98df-411e-49d5-8233-8d4857106cf3" providerId="ADAL" clId="{B598BFAD-5F30-4432-A8E7-25629D7821CF}" dt="2025-10-23T23:50:09.035" v="9" actId="255"/>
          <ac:spMkLst>
            <pc:docMk/>
            <pc:sldMk cId="2100341470" sldId="378"/>
            <ac:spMk id="3" creationId="{3D4CEB85-0752-6E3F-3E17-A45343F659FB}"/>
          </ac:spMkLst>
        </pc:spChg>
        <pc:picChg chg="del">
          <ac:chgData name="Shrestha, Avinash" userId="5add98df-411e-49d5-8233-8d4857106cf3" providerId="ADAL" clId="{B598BFAD-5F30-4432-A8E7-25629D7821CF}" dt="2025-10-23T23:48:15.678" v="0" actId="478"/>
          <ac:picMkLst>
            <pc:docMk/>
            <pc:sldMk cId="2100341470" sldId="378"/>
            <ac:picMk id="12" creationId="{761AF689-D619-44C6-0DFA-92D3929BDC32}"/>
          </ac:picMkLst>
        </pc:picChg>
        <pc:picChg chg="add mod">
          <ac:chgData name="Shrestha, Avinash" userId="5add98df-411e-49d5-8233-8d4857106cf3" providerId="ADAL" clId="{B598BFAD-5F30-4432-A8E7-25629D7821CF}" dt="2025-10-23T23:48:21.300" v="2" actId="27614"/>
          <ac:picMkLst>
            <pc:docMk/>
            <pc:sldMk cId="2100341470" sldId="378"/>
            <ac:picMk id="14" creationId="{0AA74C4D-44C4-2821-E32C-DB9DBC47C65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18A880-FBBD-4631-B292-454E4629069F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6338" y="1162050"/>
            <a:ext cx="45307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712613-E2D8-4E40-8AA9-ECC1EDC6B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47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701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33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83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833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104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905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7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917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447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90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313A-9239-46AE-8E81-9652ADF8B2E0}" type="datetimeFigureOut">
              <a:rPr lang="en-US" smtClean="0"/>
              <a:t>10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06C9F-A281-439D-97C6-E2FBEE835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graph of a number of snps&#10;&#10;AI-generated content may be incorrect.">
            <a:extLst>
              <a:ext uri="{FF2B5EF4-FFF2-40B4-BE49-F238E27FC236}">
                <a16:creationId xmlns:a16="http://schemas.microsoft.com/office/drawing/2014/main" id="{0AA74C4D-44C4-2821-E32C-DB9DBC47C6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194" y="1371596"/>
            <a:ext cx="5943612" cy="411480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D4CEB85-0752-6E3F-3E17-A45343F659FB}"/>
              </a:ext>
            </a:extLst>
          </p:cNvPr>
          <p:cNvSpPr txBox="1"/>
          <p:nvPr/>
        </p:nvSpPr>
        <p:spPr>
          <a:xfrm>
            <a:off x="733330" y="5838740"/>
            <a:ext cx="873659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or allele frequency (MAF) distribution of retained SNPs; most markers have intermediate MAF (0.10–0.45), consistent with high informativeness.</a:t>
            </a:r>
          </a:p>
        </p:txBody>
      </p:sp>
    </p:spTree>
    <p:extLst>
      <p:ext uri="{BB962C8B-B14F-4D97-AF65-F5344CB8AC3E}">
        <p14:creationId xmlns:p14="http://schemas.microsoft.com/office/powerpoint/2010/main" val="2100341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230</TotalTime>
  <Words>2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isk</dc:creator>
  <cp:lastModifiedBy>Shrestha, Avinash</cp:lastModifiedBy>
  <cp:revision>14</cp:revision>
  <cp:lastPrinted>2024-11-20T18:37:47Z</cp:lastPrinted>
  <dcterms:created xsi:type="dcterms:W3CDTF">2016-05-26T16:30:45Z</dcterms:created>
  <dcterms:modified xsi:type="dcterms:W3CDTF">2025-10-23T23:50:10Z</dcterms:modified>
</cp:coreProperties>
</file>